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6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8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77CDF05C-1F70-46C1-A7D2-D9EBD4157D68}"/>
    <pc:docChg chg="delSld modSld">
      <pc:chgData name="Najafi, Allison" userId="0304a55d-1748-4b32-895c-375cbdec2d3f" providerId="ADAL" clId="{77CDF05C-1F70-46C1-A7D2-D9EBD4157D68}" dt="2025-02-12T22:43:17.134" v="9" actId="2165"/>
      <pc:docMkLst>
        <pc:docMk/>
      </pc:docMkLst>
      <pc:sldChg chg="del">
        <pc:chgData name="Najafi, Allison" userId="0304a55d-1748-4b32-895c-375cbdec2d3f" providerId="ADAL" clId="{77CDF05C-1F70-46C1-A7D2-D9EBD4157D68}" dt="2025-01-27T21:34:07.390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77CDF05C-1F70-46C1-A7D2-D9EBD4157D68}" dt="2025-01-27T21:34:07.810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77CDF05C-1F70-46C1-A7D2-D9EBD4157D68}" dt="2025-01-27T21:34:08.999" v="3" actId="47"/>
        <pc:sldMkLst>
          <pc:docMk/>
          <pc:sldMk cId="2505032853" sldId="258"/>
        </pc:sldMkLst>
      </pc:sldChg>
      <pc:sldChg chg="del">
        <pc:chgData name="Najafi, Allison" userId="0304a55d-1748-4b32-895c-375cbdec2d3f" providerId="ADAL" clId="{77CDF05C-1F70-46C1-A7D2-D9EBD4157D68}" dt="2025-01-27T21:34:11.928" v="6" actId="47"/>
        <pc:sldMkLst>
          <pc:docMk/>
          <pc:sldMk cId="2305346892" sldId="259"/>
        </pc:sldMkLst>
      </pc:sldChg>
      <pc:sldChg chg="del">
        <pc:chgData name="Najafi, Allison" userId="0304a55d-1748-4b32-895c-375cbdec2d3f" providerId="ADAL" clId="{77CDF05C-1F70-46C1-A7D2-D9EBD4157D68}" dt="2025-01-27T21:34:08.046" v="2" actId="47"/>
        <pc:sldMkLst>
          <pc:docMk/>
          <pc:sldMk cId="2192517872" sldId="260"/>
        </pc:sldMkLst>
      </pc:sldChg>
      <pc:sldChg chg="modSp mod">
        <pc:chgData name="Najafi, Allison" userId="0304a55d-1748-4b32-895c-375cbdec2d3f" providerId="ADAL" clId="{77CDF05C-1F70-46C1-A7D2-D9EBD4157D68}" dt="2025-02-12T22:43:17.134" v="9" actId="2165"/>
        <pc:sldMkLst>
          <pc:docMk/>
          <pc:sldMk cId="3507118384" sldId="262"/>
        </pc:sldMkLst>
        <pc:graphicFrameChg chg="modGraphic">
          <ac:chgData name="Najafi, Allison" userId="0304a55d-1748-4b32-895c-375cbdec2d3f" providerId="ADAL" clId="{77CDF05C-1F70-46C1-A7D2-D9EBD4157D68}" dt="2025-02-12T22:43:17.134" v="9" actId="2165"/>
          <ac:graphicFrameMkLst>
            <pc:docMk/>
            <pc:sldMk cId="3507118384" sldId="262"/>
            <ac:graphicFrameMk id="2" creationId="{2812246F-E077-3AC0-07A5-2F80D20BBD9F}"/>
          </ac:graphicFrameMkLst>
        </pc:graphicFrameChg>
      </pc:sldChg>
      <pc:sldChg chg="del">
        <pc:chgData name="Najafi, Allison" userId="0304a55d-1748-4b32-895c-375cbdec2d3f" providerId="ADAL" clId="{77CDF05C-1F70-46C1-A7D2-D9EBD4157D68}" dt="2025-01-27T21:34:11.673" v="5" actId="47"/>
        <pc:sldMkLst>
          <pc:docMk/>
          <pc:sldMk cId="3515496556" sldId="263"/>
        </pc:sldMkLst>
      </pc:sldChg>
      <pc:sldChg chg="del">
        <pc:chgData name="Najafi, Allison" userId="0304a55d-1748-4b32-895c-375cbdec2d3f" providerId="ADAL" clId="{77CDF05C-1F70-46C1-A7D2-D9EBD4157D68}" dt="2025-01-27T21:34:12.376" v="7" actId="47"/>
        <pc:sldMkLst>
          <pc:docMk/>
          <pc:sldMk cId="2264077816" sldId="264"/>
        </pc:sldMkLst>
      </pc:sldChg>
      <pc:sldChg chg="del">
        <pc:chgData name="Najafi, Allison" userId="0304a55d-1748-4b32-895c-375cbdec2d3f" providerId="ADAL" clId="{77CDF05C-1F70-46C1-A7D2-D9EBD4157D68}" dt="2025-01-27T21:34:13.022" v="8" actId="47"/>
        <pc:sldMkLst>
          <pc:docMk/>
          <pc:sldMk cId="639073537" sldId="265"/>
        </pc:sldMkLst>
      </pc:sldChg>
      <pc:sldChg chg="del">
        <pc:chgData name="Najafi, Allison" userId="0304a55d-1748-4b32-895c-375cbdec2d3f" providerId="ADAL" clId="{77CDF05C-1F70-46C1-A7D2-D9EBD4157D68}" dt="2025-01-27T21:34:09.777" v="4" actId="47"/>
        <pc:sldMkLst>
          <pc:docMk/>
          <pc:sldMk cId="1558034745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812246F-E077-3AC0-07A5-2F80D20BBD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1613094"/>
              </p:ext>
            </p:extLst>
          </p:nvPr>
        </p:nvGraphicFramePr>
        <p:xfrm>
          <a:off x="380433" y="295655"/>
          <a:ext cx="5307986" cy="537007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92923">
                  <a:extLst>
                    <a:ext uri="{9D8B030D-6E8A-4147-A177-3AD203B41FA5}">
                      <a16:colId xmlns:a16="http://schemas.microsoft.com/office/drawing/2014/main" val="2804526775"/>
                    </a:ext>
                  </a:extLst>
                </a:gridCol>
                <a:gridCol w="1060777">
                  <a:extLst>
                    <a:ext uri="{9D8B030D-6E8A-4147-A177-3AD203B41FA5}">
                      <a16:colId xmlns:a16="http://schemas.microsoft.com/office/drawing/2014/main" val="2600355166"/>
                    </a:ext>
                  </a:extLst>
                </a:gridCol>
                <a:gridCol w="1327143">
                  <a:extLst>
                    <a:ext uri="{9D8B030D-6E8A-4147-A177-3AD203B41FA5}">
                      <a16:colId xmlns:a16="http://schemas.microsoft.com/office/drawing/2014/main" val="232903591"/>
                    </a:ext>
                  </a:extLst>
                </a:gridCol>
                <a:gridCol w="1327143">
                  <a:extLst>
                    <a:ext uri="{9D8B030D-6E8A-4147-A177-3AD203B41FA5}">
                      <a16:colId xmlns:a16="http://schemas.microsoft.com/office/drawing/2014/main" val="708291631"/>
                    </a:ext>
                  </a:extLst>
                </a:gridCol>
              </a:tblGrid>
              <a:tr h="2277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TUR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V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UL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048960"/>
                  </a:ext>
                </a:extLst>
              </a:tr>
              <a:tr h="2690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erioperative Use Only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3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18026764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7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1003329"/>
                  </a:ext>
                </a:extLst>
              </a:tr>
              <a:tr h="215142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-year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3716773"/>
                  </a:ext>
                </a:extLst>
              </a:tr>
              <a:tr h="4414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9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5034978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1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1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3404038"/>
                  </a:ext>
                </a:extLst>
              </a:tr>
              <a:tr h="29249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1798955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8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51633029"/>
                  </a:ext>
                </a:extLst>
              </a:tr>
              <a:tr h="2277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3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6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29030857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9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3208796"/>
                  </a:ext>
                </a:extLst>
              </a:tr>
              <a:tr h="215142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-yea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1347125"/>
                  </a:ext>
                </a:extLst>
              </a:tr>
              <a:tr h="4414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5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4497924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.2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6068142"/>
                  </a:ext>
                </a:extLst>
              </a:tr>
              <a:tr h="29249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 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4681237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.1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.2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9877285"/>
                  </a:ext>
                </a:extLst>
              </a:tr>
              <a:tr h="21514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2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7419331"/>
                  </a:ext>
                </a:extLst>
              </a:tr>
              <a:tr h="129402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59101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7118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3</TotalTime>
  <Words>180</Words>
  <Application>Microsoft Office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2-12T22:43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